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0960E-5D03-4B1E-AD8B-4F8BEE38B5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84B91-DE13-4EFE-B425-651866CBAF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EC26D-2D84-4859-9E4F-073F9381FD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33A69-E921-4D72-8B5E-9CABDFA905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1CB37-A282-43A8-879E-92AF81F9D4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BAC57-3A65-414F-8B67-792AB0B9CC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7D6C9-C07B-471E-A024-28D544DA83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C1795-5979-4AE7-891B-8CD8344F89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6C860-7FCF-430D-B12B-71769C4657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1D6B6-47BE-449A-A980-22539BDC8D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C4508-70FC-4A43-A1A7-426AD57A8A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4A32C-D36F-496D-85F1-3D1275D0E7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FAF0E8-1E72-4BE6-8A96-7FA65EE8C063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5CB481-1605-410E-96F2-73546EDF7CC3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4" descr="gA.jpg"/>
          <p:cNvPicPr/>
          <p:nvPr/>
        </p:nvPicPr>
        <p:blipFill>
          <a:blip r:embed="rId1"/>
          <a:stretch/>
        </p:blipFill>
        <p:spPr>
          <a:xfrm>
            <a:off x="0" y="1197000"/>
            <a:ext cx="4038480" cy="2955960"/>
          </a:xfrm>
          <a:prstGeom prst="rect">
            <a:avLst/>
          </a:prstGeom>
          <a:ln w="0">
            <a:noFill/>
          </a:ln>
        </p:spPr>
      </p:pic>
      <p:pic>
        <p:nvPicPr>
          <p:cNvPr id="42" name="Grafik 6" descr="3D.jpg"/>
          <p:cNvPicPr/>
          <p:nvPr/>
        </p:nvPicPr>
        <p:blipFill>
          <a:blip r:embed="rId2"/>
          <a:stretch/>
        </p:blipFill>
        <p:spPr>
          <a:xfrm>
            <a:off x="4427640" y="4011480"/>
            <a:ext cx="3603600" cy="2846520"/>
          </a:xfrm>
          <a:prstGeom prst="rect">
            <a:avLst/>
          </a:prstGeom>
          <a:ln w="0">
            <a:noFill/>
          </a:ln>
        </p:spPr>
      </p:pic>
      <p:pic>
        <p:nvPicPr>
          <p:cNvPr id="43" name="Grafik 7" descr="gC.jpg"/>
          <p:cNvPicPr/>
          <p:nvPr/>
        </p:nvPicPr>
        <p:blipFill>
          <a:blip r:embed="rId3"/>
          <a:stretch/>
        </p:blipFill>
        <p:spPr>
          <a:xfrm>
            <a:off x="4067280" y="1197000"/>
            <a:ext cx="4038480" cy="2955960"/>
          </a:xfrm>
          <a:prstGeom prst="rect">
            <a:avLst/>
          </a:prstGeom>
          <a:ln w="0">
            <a:noFill/>
          </a:ln>
        </p:spPr>
      </p:pic>
      <p:pic>
        <p:nvPicPr>
          <p:cNvPr id="44" name="Grafik 8" descr="3A.jpg"/>
          <p:cNvPicPr/>
          <p:nvPr/>
        </p:nvPicPr>
        <p:blipFill>
          <a:blip r:embed="rId4"/>
          <a:stretch/>
        </p:blipFill>
        <p:spPr>
          <a:xfrm>
            <a:off x="324000" y="4011480"/>
            <a:ext cx="3601800" cy="2846520"/>
          </a:xfrm>
          <a:prstGeom prst="rect">
            <a:avLst/>
          </a:prstGeom>
          <a:ln w="0">
            <a:noFill/>
          </a:ln>
        </p:spPr>
      </p:pic>
      <p:sp>
        <p:nvSpPr>
          <p:cNvPr id="45" name="Textfeld 13"/>
          <p:cNvSpPr/>
          <p:nvPr/>
        </p:nvSpPr>
        <p:spPr>
          <a:xfrm>
            <a:off x="233280" y="0"/>
            <a:ext cx="8675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Supplementary material g. 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Differences in the expression level of T cell activation markers between subgroups of HIV-1-infected patients living in Nouna (rural) and Ouagadougou (urban). Only patients with similar CD4</a:t>
            </a:r>
            <a:r>
              <a:rPr b="0" lang="de-DE" sz="12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 T cell counts or similar HIV-1-plasma viral load levels were compar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feld 5"/>
          <p:cNvSpPr/>
          <p:nvPr/>
        </p:nvSpPr>
        <p:spPr>
          <a:xfrm>
            <a:off x="232920" y="692280"/>
            <a:ext cx="431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CD4 count between 200 and 399 cells/mm</a:t>
            </a:r>
            <a:r>
              <a:rPr b="1" lang="de-DE" sz="18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feld 6"/>
          <p:cNvSpPr/>
          <p:nvPr/>
        </p:nvSpPr>
        <p:spPr>
          <a:xfrm>
            <a:off x="4501080" y="692280"/>
            <a:ext cx="464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Viral load between 4.0 and 5.9 log10 copies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7T14:15:46Z</dcterms:created>
  <dc:creator>Fabrice Tiba</dc:creator>
  <dc:description/>
  <dc:language>en-US</dc:language>
  <cp:lastModifiedBy>LG</cp:lastModifiedBy>
  <dcterms:modified xsi:type="dcterms:W3CDTF">2011-11-07T17:18:09Z</dcterms:modified>
  <cp:revision>2</cp:revision>
  <dc:subject/>
  <dc:title>Folie 1</dc:title>
</cp:coreProperties>
</file>